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483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A27EFAA-CC11-A30F-3ADA-80BC735A5E2A}" name="Deepika Godugu" initials="DG" userId="de63707ed9614b77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4CA3AC7-3EF7-184C-9D35-101BA6C65E04}" v="10" dt="2025-09-23T20:31:37.07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66"/>
    <p:restoredTop sz="94110" autoAdjust="0"/>
  </p:normalViewPr>
  <p:slideViewPr>
    <p:cSldViewPr snapToGrid="0">
      <p:cViewPr>
        <p:scale>
          <a:sx n="75" d="100"/>
          <a:sy n="75" d="100"/>
        </p:scale>
        <p:origin x="3768" y="1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65C485-E7F4-457F-8324-55443022CE20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7F2D38-B731-4F73-84CE-D0F3B4FF7C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646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D498B-CA5C-BB45-A879-7CE03A8C34DA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9C557-9EDB-124D-8C3E-E75D9A99E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8241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D498B-CA5C-BB45-A879-7CE03A8C34DA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9C557-9EDB-124D-8C3E-E75D9A99E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726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D498B-CA5C-BB45-A879-7CE03A8C34DA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9C557-9EDB-124D-8C3E-E75D9A99E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3000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D498B-CA5C-BB45-A879-7CE03A8C34DA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9C557-9EDB-124D-8C3E-E75D9A99E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247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D498B-CA5C-BB45-A879-7CE03A8C34DA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9C557-9EDB-124D-8C3E-E75D9A99E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862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D498B-CA5C-BB45-A879-7CE03A8C34DA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9C557-9EDB-124D-8C3E-E75D9A99E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8304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D498B-CA5C-BB45-A879-7CE03A8C34DA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9C557-9EDB-124D-8C3E-E75D9A99E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061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D498B-CA5C-BB45-A879-7CE03A8C34DA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9C557-9EDB-124D-8C3E-E75D9A99E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032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D498B-CA5C-BB45-A879-7CE03A8C34DA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9C557-9EDB-124D-8C3E-E75D9A99E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511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D498B-CA5C-BB45-A879-7CE03A8C34DA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9C557-9EDB-124D-8C3E-E75D9A99E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4103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D498B-CA5C-BB45-A879-7CE03A8C34DA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9C557-9EDB-124D-8C3E-E75D9A99E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950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CD498B-CA5C-BB45-A879-7CE03A8C34DA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39C557-9EDB-124D-8C3E-E75D9A99E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755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692DD2A-2824-192E-0DFB-6E5C7FF48523}"/>
              </a:ext>
            </a:extLst>
          </p:cNvPr>
          <p:cNvSpPr txBox="1"/>
          <p:nvPr/>
        </p:nvSpPr>
        <p:spPr>
          <a:xfrm>
            <a:off x="2446304" y="5141495"/>
            <a:ext cx="2728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8AB801E-9A40-E7E0-D659-6DFB1A9E3ED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964" t="2615" r="4092" b="10224"/>
          <a:stretch>
            <a:fillRect/>
          </a:stretch>
        </p:blipFill>
        <p:spPr>
          <a:xfrm>
            <a:off x="2359257" y="5418494"/>
            <a:ext cx="2139483" cy="169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7D6CB8AD-CE4A-2222-052E-3737EECD8BA4}"/>
              </a:ext>
            </a:extLst>
          </p:cNvPr>
          <p:cNvSpPr txBox="1"/>
          <p:nvPr/>
        </p:nvSpPr>
        <p:spPr>
          <a:xfrm>
            <a:off x="217235" y="7512423"/>
            <a:ext cx="6399465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Figure S1.</a:t>
            </a:r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</a:t>
            </a:r>
            <a:r>
              <a:rPr lang="en-US" sz="12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CXCR1</a:t>
            </a:r>
            <a:r>
              <a:rPr lang="en-US" sz="1200" b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expression </a:t>
            </a:r>
            <a:r>
              <a:rPr lang="en-US" sz="1200" dirty="0">
                <a:solidFill>
                  <a:srgbClr val="222222"/>
                </a:solidFill>
                <a:latin typeface="Arial" panose="020B0604020202020204" pitchFamily="34" charset="0"/>
              </a:rPr>
              <a:t>s</a:t>
            </a:r>
            <a:r>
              <a:rPr lang="en-US" sz="1200" b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trongly </a:t>
            </a:r>
            <a:r>
              <a:rPr lang="en-US" sz="1200" dirty="0">
                <a:solidFill>
                  <a:srgbClr val="222222"/>
                </a:solidFill>
                <a:latin typeface="Arial" panose="020B0604020202020204" pitchFamily="34" charset="0"/>
              </a:rPr>
              <a:t>c</a:t>
            </a:r>
            <a:r>
              <a:rPr lang="en-US" sz="1200" b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orrelates with poor </a:t>
            </a:r>
            <a:r>
              <a:rPr lang="en-US" sz="1200" dirty="0">
                <a:solidFill>
                  <a:srgbClr val="222222"/>
                </a:solidFill>
                <a:latin typeface="Arial" panose="020B0604020202020204" pitchFamily="34" charset="0"/>
              </a:rPr>
              <a:t>s</a:t>
            </a:r>
            <a:r>
              <a:rPr lang="en-US" sz="1200" b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urvival of NB patients</a:t>
            </a:r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. Kaplan–Meier survival analysis of the </a:t>
            </a:r>
            <a:r>
              <a:rPr lang="en-US" sz="12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CXCR1</a:t>
            </a:r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gene shows a better overall probability of NB </a:t>
            </a:r>
            <a:r>
              <a:rPr lang="en-US" sz="1200" dirty="0">
                <a:solidFill>
                  <a:srgbClr val="222222"/>
                </a:solidFill>
                <a:latin typeface="Arial" panose="020B0604020202020204" pitchFamily="34" charset="0"/>
              </a:rPr>
              <a:t>patients' </a:t>
            </a:r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survival. (</a:t>
            </a:r>
            <a:r>
              <a:rPr lang="en-US" sz="1200" b="1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A</a:t>
            </a:r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) Versteeg dataset (N = 88 patients). (</a:t>
            </a:r>
            <a:r>
              <a:rPr lang="en-US" sz="1200" b="1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B</a:t>
            </a:r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) Kocak dataset (N = 649 patients). (</a:t>
            </a:r>
            <a:r>
              <a:rPr lang="en-US" sz="1200" b="1" dirty="0">
                <a:solidFill>
                  <a:srgbClr val="222222"/>
                </a:solidFill>
                <a:latin typeface="Arial" panose="020B0604020202020204" pitchFamily="34" charset="0"/>
              </a:rPr>
              <a:t>C</a:t>
            </a:r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) RPM dataset (N = 498 patients). (</a:t>
            </a:r>
            <a:r>
              <a:rPr lang="en-US" sz="1200" b="1" dirty="0">
                <a:solidFill>
                  <a:srgbClr val="222222"/>
                </a:solidFill>
                <a:latin typeface="Arial" panose="020B0604020202020204" pitchFamily="34" charset="0"/>
              </a:rPr>
              <a:t>D</a:t>
            </a:r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) </a:t>
            </a:r>
            <a:r>
              <a:rPr lang="en-US" sz="1200" b="0" i="0" dirty="0" err="1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Oberthuer</a:t>
            </a:r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dataset (N = 251 patients). </a:t>
            </a:r>
            <a:r>
              <a:rPr lang="en-US" sz="1200" b="1" dirty="0">
                <a:solidFill>
                  <a:srgbClr val="222222"/>
                </a:solidFill>
                <a:latin typeface="Arial" panose="020B0604020202020204" pitchFamily="34" charset="0"/>
              </a:rPr>
              <a:t>(E) </a:t>
            </a:r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Expression of CXCR1 and CXCR2 gene in NB cell line</a:t>
            </a:r>
            <a:r>
              <a:rPr lang="en-US" sz="1200" dirty="0">
                <a:solidFill>
                  <a:srgbClr val="222222"/>
                </a:solidFill>
                <a:latin typeface="Arial" panose="020B0604020202020204" pitchFamily="34" charset="0"/>
              </a:rPr>
              <a:t>s in the Chapple dataset (N=35323)</a:t>
            </a:r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.</a:t>
            </a:r>
            <a:endParaRPr lang="en-US" sz="12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FD7A243-1BBF-E661-51B7-6242F6ACB0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7236" y="126494"/>
            <a:ext cx="6003526" cy="5292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45F6712-880D-050C-CCB3-8F629DA7F9B3}"/>
              </a:ext>
            </a:extLst>
          </p:cNvPr>
          <p:cNvSpPr txBox="1"/>
          <p:nvPr/>
        </p:nvSpPr>
        <p:spPr>
          <a:xfrm>
            <a:off x="2359257" y="541849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2722715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36df893f-0dd4-4127-97a5-bc537bcdc62a}" enabled="0" method="" siteId="{36df893f-0dd4-4127-97a5-bc537bcdc62a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61</TotalTime>
  <Words>102</Words>
  <Application>Microsoft Office PowerPoint</Application>
  <PresentationFormat>Letter Paper (8.5x11 in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urabh Agarwal</dc:creator>
  <cp:lastModifiedBy>MDPI</cp:lastModifiedBy>
  <cp:revision>26</cp:revision>
  <dcterms:created xsi:type="dcterms:W3CDTF">2024-10-14T21:39:56Z</dcterms:created>
  <dcterms:modified xsi:type="dcterms:W3CDTF">2025-10-14T10:26:40Z</dcterms:modified>
</cp:coreProperties>
</file>